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81800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0698A5-640F-45EF-8DC2-70DCF13B93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20C7F8-6EC7-4405-B8D8-1C229CD16A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CB86F9-4E87-4B8F-B4CF-F279D74376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2FA50-B28D-4DCB-BC46-DE616FA351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E40207-1644-4659-ABC4-D1FA056D46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C8ED45-4D09-4B02-9152-F076D72A9A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49B6DA-C24D-45BC-8CD4-5446128E6F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90532-50C2-459C-BE08-6B2A142F08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45F7AE-5A3C-4FBF-912C-FE767D3D07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EFEB7-FA33-4629-B5FE-81D0F0A8C9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BC827-916D-4C70-9904-5D8569FB5B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5658C-A507-4590-AA1D-5DAB413486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0A4449-7226-4444-8B6B-B90C34363AFD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57200" y="752400"/>
            <a:ext cx="5867280" cy="7788240"/>
            <a:chOff x="457200" y="752400"/>
            <a:chExt cx="5867280" cy="778824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457200" y="755640"/>
              <a:ext cx="1828800" cy="146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tretch/>
          </p:blipFill>
          <p:spPr>
            <a:xfrm>
              <a:off x="2590920" y="752400"/>
              <a:ext cx="1828800" cy="146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3"/>
            <a:stretch/>
          </p:blipFill>
          <p:spPr>
            <a:xfrm>
              <a:off x="2600280" y="2327400"/>
              <a:ext cx="1814400" cy="1452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4"/>
            <a:stretch/>
          </p:blipFill>
          <p:spPr>
            <a:xfrm>
              <a:off x="4495680" y="3965400"/>
              <a:ext cx="1828800" cy="146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5"/>
            <a:stretch/>
          </p:blipFill>
          <p:spPr>
            <a:xfrm>
              <a:off x="457200" y="3946680"/>
              <a:ext cx="1832040" cy="1466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6"/>
            <a:stretch/>
          </p:blipFill>
          <p:spPr>
            <a:xfrm>
              <a:off x="457200" y="2322360"/>
              <a:ext cx="1828800" cy="146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" descr=""/>
            <p:cNvPicPr/>
            <p:nvPr/>
          </p:nvPicPr>
          <p:blipFill>
            <a:blip r:embed="rId7"/>
            <a:stretch/>
          </p:blipFill>
          <p:spPr>
            <a:xfrm>
              <a:off x="4495680" y="2311560"/>
              <a:ext cx="1828800" cy="1461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" descr=""/>
            <p:cNvPicPr/>
            <p:nvPr/>
          </p:nvPicPr>
          <p:blipFill>
            <a:blip r:embed="rId8"/>
            <a:stretch/>
          </p:blipFill>
          <p:spPr>
            <a:xfrm>
              <a:off x="2590920" y="3946680"/>
              <a:ext cx="1825560" cy="1460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" descr=""/>
            <p:cNvPicPr/>
            <p:nvPr/>
          </p:nvPicPr>
          <p:blipFill>
            <a:blip r:embed="rId9"/>
            <a:stretch/>
          </p:blipFill>
          <p:spPr>
            <a:xfrm>
              <a:off x="465120" y="5497560"/>
              <a:ext cx="1822320" cy="145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" descr=""/>
            <p:cNvPicPr/>
            <p:nvPr/>
          </p:nvPicPr>
          <p:blipFill>
            <a:blip r:embed="rId10"/>
            <a:stretch/>
          </p:blipFill>
          <p:spPr>
            <a:xfrm>
              <a:off x="466560" y="7058160"/>
              <a:ext cx="1819440" cy="14554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2" name=""/>
            <p:cNvGrpSpPr/>
            <p:nvPr/>
          </p:nvGrpSpPr>
          <p:grpSpPr>
            <a:xfrm>
              <a:off x="4486320" y="762120"/>
              <a:ext cx="1819080" cy="1454040"/>
              <a:chOff x="4486320" y="762120"/>
              <a:chExt cx="1819080" cy="1454040"/>
            </a:xfrm>
          </p:grpSpPr>
          <p:sp>
            <p:nvSpPr>
              <p:cNvPr id="53" name=""/>
              <p:cNvSpPr/>
              <p:nvPr/>
            </p:nvSpPr>
            <p:spPr>
              <a:xfrm>
                <a:off x="4486320" y="762120"/>
                <a:ext cx="1819080" cy="1454040"/>
              </a:xfrm>
              <a:custGeom>
                <a:avLst/>
                <a:gdLst/>
                <a:ahLst/>
                <a:rect l="l" t="t" r="r" b="b"/>
                <a:pathLst>
                  <a:path w="1146" h="916">
                    <a:moveTo>
                      <a:pt x="1146" y="916"/>
                    </a:moveTo>
                    <a:lnTo>
                      <a:pt x="0" y="0"/>
                    </a:lnTo>
                    <a:lnTo>
                      <a:pt x="0" y="916"/>
                    </a:lnTo>
                    <a:lnTo>
                      <a:pt x="1146" y="916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486320" y="762120"/>
                <a:ext cx="1819080" cy="1454040"/>
              </a:xfrm>
              <a:custGeom>
                <a:avLst/>
                <a:gdLst/>
                <a:ahLst/>
                <a:rect l="l" t="t" r="r" b="b"/>
                <a:pathLst>
                  <a:path w="1146" h="916">
                    <a:moveTo>
                      <a:pt x="0" y="0"/>
                    </a:moveTo>
                    <a:lnTo>
                      <a:pt x="1146" y="0"/>
                    </a:lnTo>
                    <a:lnTo>
                      <a:pt x="1146" y="91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4486320" y="762120"/>
                <a:ext cx="1819080" cy="1454040"/>
              </a:xfrm>
              <a:custGeom>
                <a:avLst/>
                <a:gdLst/>
                <a:ahLst/>
                <a:rect l="l" t="t" r="r" b="b"/>
                <a:pathLst>
                  <a:path w="1146" h="916">
                    <a:moveTo>
                      <a:pt x="1146" y="916"/>
                    </a:moveTo>
                    <a:lnTo>
                      <a:pt x="0" y="0"/>
                    </a:lnTo>
                    <a:lnTo>
                      <a:pt x="0" y="916"/>
                    </a:lnTo>
                    <a:lnTo>
                      <a:pt x="1146" y="916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4486320" y="762120"/>
                <a:ext cx="1819080" cy="1454040"/>
              </a:xfrm>
              <a:custGeom>
                <a:avLst/>
                <a:gdLst/>
                <a:ahLst/>
                <a:rect l="l" t="t" r="r" b="b"/>
                <a:pathLst>
                  <a:path w="1146" h="916">
                    <a:moveTo>
                      <a:pt x="0" y="0"/>
                    </a:moveTo>
                    <a:lnTo>
                      <a:pt x="1146" y="0"/>
                    </a:lnTo>
                    <a:lnTo>
                      <a:pt x="1146" y="91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5364360" y="2120760"/>
                <a:ext cx="21708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RAR beta</a:t>
                </a:r>
                <a:endParaRPr b="0" lang="en-US" sz="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6226560" y="199548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5972400" y="199548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5730120" y="199548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5479200" y="199548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5228640" y="199548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4977720" y="199548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4723560" y="199548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 rot="16200000">
                <a:off x="4451040" y="1318680"/>
                <a:ext cx="31608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PPAR gamma</a:t>
                </a:r>
                <a:endParaRPr b="0" lang="en-US" sz="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4690440" y="81108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4690440" y="103968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4690440" y="126684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4690440" y="149400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4690440" y="172260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4690440" y="193032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6232680" y="198432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5981760" y="198432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5730840" y="1984320"/>
                <a:ext cx="180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5477040" y="198432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5226120" y="198432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4976640" y="1984320"/>
                <a:ext cx="180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4726080" y="198432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4714920" y="833400"/>
                <a:ext cx="111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4714920" y="1062000"/>
                <a:ext cx="111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4714920" y="1293840"/>
                <a:ext cx="1116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4714920" y="1521000"/>
                <a:ext cx="1116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4714920" y="1752480"/>
                <a:ext cx="111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4714920" y="1979640"/>
                <a:ext cx="1116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4726080" y="833400"/>
                <a:ext cx="1506600" cy="1146240"/>
              </a:xfrm>
              <a:custGeom>
                <a:avLst/>
                <a:gdLst/>
                <a:ahLst/>
                <a:rect l="l" t="t" r="r" b="b"/>
                <a:pathLst>
                  <a:path w="949" h="722">
                    <a:moveTo>
                      <a:pt x="949" y="722"/>
                    </a:moveTo>
                    <a:lnTo>
                      <a:pt x="0" y="0"/>
                    </a:lnTo>
                    <a:lnTo>
                      <a:pt x="0" y="722"/>
                    </a:lnTo>
                    <a:lnTo>
                      <a:pt x="949" y="722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4726080" y="833400"/>
                <a:ext cx="1506600" cy="1146240"/>
              </a:xfrm>
              <a:custGeom>
                <a:avLst/>
                <a:gdLst/>
                <a:ahLst/>
                <a:rect l="l" t="t" r="r" b="b"/>
                <a:pathLst>
                  <a:path w="949" h="722">
                    <a:moveTo>
                      <a:pt x="0" y="0"/>
                    </a:moveTo>
                    <a:lnTo>
                      <a:pt x="949" y="0"/>
                    </a:lnTo>
                    <a:lnTo>
                      <a:pt x="949" y="7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4726080" y="833400"/>
                <a:ext cx="1506600" cy="11462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5094360" y="132732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4930920" y="1749600"/>
                <a:ext cx="140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4881600" y="188928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5564160" y="183996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4843440" y="164952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5059440" y="1908000"/>
                <a:ext cx="1584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919760" y="1512720"/>
                <a:ext cx="1404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5146560" y="180972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4756320" y="177156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4740120" y="179388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4933800" y="1703520"/>
                <a:ext cx="162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4900680" y="163512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4911840" y="178272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4827600" y="161280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5187960" y="146052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4884840" y="1346040"/>
                <a:ext cx="1584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4983120" y="16732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4933800" y="895320"/>
                <a:ext cx="162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4900680" y="168120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5067360" y="163512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5203800" y="113040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4991040" y="182880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4930920" y="1900080"/>
                <a:ext cx="1404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5583240" y="189216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4794120" y="172548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4797360" y="18478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5116680" y="14065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5556240" y="178596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4782960" y="173664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4778280" y="179064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5176800" y="16732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5234040" y="168120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4884840" y="18241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5100480" y="1733400"/>
                <a:ext cx="1620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5416560" y="16462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4843440" y="161604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5083200" y="176832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5170320" y="144144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5214960" y="181296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5522760" y="179388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5522760" y="123984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4884840" y="181764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4964040" y="189216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5784840" y="18702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835520" y="171144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4816440" y="185580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5234040" y="147960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6076800" y="178272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4748040" y="1703520"/>
                <a:ext cx="162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4797360" y="17827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5345280" y="160488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5299200" y="162720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4991040" y="177156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4925880" y="178596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5151600" y="164952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4994280" y="161280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5059440" y="177156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5203800" y="139536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5127480" y="178272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5575320" y="17938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 flipV="1">
                <a:off x="5481720" y="1668240"/>
                <a:ext cx="750960" cy="126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 flipV="1">
                <a:off x="4726080" y="1681200"/>
                <a:ext cx="755640" cy="64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4726080" y="1979640"/>
                <a:ext cx="150660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 flipV="1">
                <a:off x="4726080" y="833400"/>
                <a:ext cx="1440" cy="11462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5893560" y="920880"/>
                <a:ext cx="1836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CC : 0.105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5883480" y="990720"/>
                <a:ext cx="1166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p : n.s.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54" name=""/>
            <p:cNvGrpSpPr/>
            <p:nvPr/>
          </p:nvGrpSpPr>
          <p:grpSpPr>
            <a:xfrm>
              <a:off x="4495680" y="5486400"/>
              <a:ext cx="1825920" cy="1461960"/>
              <a:chOff x="4495680" y="5486400"/>
              <a:chExt cx="1825920" cy="1461960"/>
            </a:xfrm>
          </p:grpSpPr>
          <p:sp>
            <p:nvSpPr>
              <p:cNvPr id="155" name=""/>
              <p:cNvSpPr/>
              <p:nvPr/>
            </p:nvSpPr>
            <p:spPr>
              <a:xfrm>
                <a:off x="4495680" y="5486400"/>
                <a:ext cx="1825920" cy="1461960"/>
              </a:xfrm>
              <a:custGeom>
                <a:avLst/>
                <a:gdLst/>
                <a:ahLst/>
                <a:rect l="l" t="t" r="r" b="b"/>
                <a:pathLst>
                  <a:path w="1150" h="921">
                    <a:moveTo>
                      <a:pt x="1150" y="921"/>
                    </a:moveTo>
                    <a:lnTo>
                      <a:pt x="0" y="0"/>
                    </a:lnTo>
                    <a:lnTo>
                      <a:pt x="0" y="921"/>
                    </a:lnTo>
                    <a:lnTo>
                      <a:pt x="1150" y="921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4495680" y="5486400"/>
                <a:ext cx="1825920" cy="1461960"/>
              </a:xfrm>
              <a:custGeom>
                <a:avLst/>
                <a:gdLst/>
                <a:ahLst/>
                <a:rect l="l" t="t" r="r" b="b"/>
                <a:pathLst>
                  <a:path w="1150" h="921">
                    <a:moveTo>
                      <a:pt x="0" y="0"/>
                    </a:moveTo>
                    <a:lnTo>
                      <a:pt x="1150" y="0"/>
                    </a:lnTo>
                    <a:lnTo>
                      <a:pt x="1150" y="92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4495680" y="5486400"/>
                <a:ext cx="1825920" cy="1461960"/>
              </a:xfrm>
              <a:custGeom>
                <a:avLst/>
                <a:gdLst/>
                <a:ahLst/>
                <a:rect l="l" t="t" r="r" b="b"/>
                <a:pathLst>
                  <a:path w="1150" h="921">
                    <a:moveTo>
                      <a:pt x="1150" y="921"/>
                    </a:moveTo>
                    <a:lnTo>
                      <a:pt x="0" y="0"/>
                    </a:lnTo>
                    <a:lnTo>
                      <a:pt x="0" y="921"/>
                    </a:lnTo>
                    <a:lnTo>
                      <a:pt x="1150" y="921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4495680" y="5486400"/>
                <a:ext cx="1825920" cy="1461960"/>
              </a:xfrm>
              <a:custGeom>
                <a:avLst/>
                <a:gdLst/>
                <a:ahLst/>
                <a:rect l="l" t="t" r="r" b="b"/>
                <a:pathLst>
                  <a:path w="1150" h="921">
                    <a:moveTo>
                      <a:pt x="0" y="0"/>
                    </a:moveTo>
                    <a:lnTo>
                      <a:pt x="1150" y="0"/>
                    </a:lnTo>
                    <a:lnTo>
                      <a:pt x="1150" y="92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5376960" y="6853320"/>
                <a:ext cx="21708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RAR beta</a:t>
                </a:r>
                <a:endParaRPr b="0" lang="en-US" sz="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6242400" y="672624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5986800" y="672624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5744520" y="672624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5492160" y="672624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5241240" y="672624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4988880" y="672624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4734720" y="672624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 rot="16200000">
                <a:off x="4497480" y="6060600"/>
                <a:ext cx="24156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RAR alpha</a:t>
                </a:r>
                <a:endParaRPr b="0" lang="en-US" sz="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4699800" y="553572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4699800" y="582300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4699800" y="610884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4699800" y="639432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4699800" y="666288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6248520" y="671508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5997600" y="671508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5745240" y="671508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5489640" y="671508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5238720" y="671508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4987800" y="6715080"/>
                <a:ext cx="180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4735440" y="6715080"/>
                <a:ext cx="180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4724280" y="5559480"/>
                <a:ext cx="1116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4724280" y="5845320"/>
                <a:ext cx="1116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4724280" y="6135840"/>
                <a:ext cx="1116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4724280" y="6424560"/>
                <a:ext cx="111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4724280" y="6711840"/>
                <a:ext cx="111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4735440" y="5559480"/>
                <a:ext cx="1513080" cy="1152360"/>
              </a:xfrm>
              <a:custGeom>
                <a:avLst/>
                <a:gdLst/>
                <a:ahLst/>
                <a:rect l="l" t="t" r="r" b="b"/>
                <a:pathLst>
                  <a:path w="953" h="726">
                    <a:moveTo>
                      <a:pt x="953" y="726"/>
                    </a:moveTo>
                    <a:lnTo>
                      <a:pt x="0" y="0"/>
                    </a:lnTo>
                    <a:lnTo>
                      <a:pt x="0" y="726"/>
                    </a:lnTo>
                    <a:lnTo>
                      <a:pt x="953" y="726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4735440" y="5559480"/>
                <a:ext cx="1513080" cy="1152360"/>
              </a:xfrm>
              <a:custGeom>
                <a:avLst/>
                <a:gdLst/>
                <a:ahLst/>
                <a:rect l="l" t="t" r="r" b="b"/>
                <a:pathLst>
                  <a:path w="953" h="726">
                    <a:moveTo>
                      <a:pt x="0" y="0"/>
                    </a:moveTo>
                    <a:lnTo>
                      <a:pt x="953" y="0"/>
                    </a:lnTo>
                    <a:lnTo>
                      <a:pt x="953" y="72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4735440" y="5559480"/>
                <a:ext cx="1513080" cy="115236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5105520" y="58294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4941720" y="632160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4892760" y="657396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5578560" y="603252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4854600" y="645948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5070600" y="6402240"/>
                <a:ext cx="1584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4930920" y="608184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5159520" y="624204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4765680" y="63216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4751280" y="642132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4944960" y="624996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4911840" y="635652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4923000" y="6418440"/>
                <a:ext cx="140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4838760" y="64054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5200560" y="563076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4896000" y="62308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4994280" y="63673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4944960" y="61578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4911840" y="643716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5078520" y="62308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5216400" y="568476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5002200" y="627696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4941720" y="659304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5597640" y="586440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4803840" y="642924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4808520" y="628812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5127480" y="5918040"/>
                <a:ext cx="162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5570640" y="615780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4792680" y="64134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4789440" y="638316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5189400" y="632160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5246640" y="6326280"/>
                <a:ext cx="144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4896000" y="6402240"/>
                <a:ext cx="1584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5113440" y="601668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5429160" y="608184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4854600" y="621180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5094360" y="628812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5181480" y="602136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5227560" y="640548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5535720" y="61308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5535720" y="557064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4896000" y="628812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4975200" y="658188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5799240" y="594036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4846680" y="637848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4827600" y="630720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5246640" y="590544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6093000" y="610092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4759200" y="6402240"/>
                <a:ext cx="1440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4808520" y="642924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5356080" y="629136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5311800" y="635652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5002200" y="637236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4937040" y="62038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5162400" y="610092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5006880" y="622620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>
                <a:off x="5070600" y="62071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5216400" y="6127920"/>
                <a:ext cx="144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5140440" y="644040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>
                <a:off x="5589720" y="631044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 flipV="1">
                <a:off x="5494320" y="5757480"/>
                <a:ext cx="754200" cy="320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 flipV="1">
                <a:off x="4735440" y="6078240"/>
                <a:ext cx="758880" cy="3157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>
                <a:off x="4735440" y="6711840"/>
                <a:ext cx="151308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 flipV="1">
                <a:off x="4735440" y="5559120"/>
                <a:ext cx="1800" cy="11523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>
                <a:off x="5907960" y="5673600"/>
                <a:ext cx="1836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CC : 0.598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>
                <a:off x="5906160" y="5761080"/>
                <a:ext cx="1728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p : &lt;0.001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254" name=""/>
            <p:cNvGrpSpPr/>
            <p:nvPr/>
          </p:nvGrpSpPr>
          <p:grpSpPr>
            <a:xfrm>
              <a:off x="2590920" y="5487840"/>
              <a:ext cx="1822320" cy="1457640"/>
              <a:chOff x="2590920" y="5487840"/>
              <a:chExt cx="1822320" cy="1457640"/>
            </a:xfrm>
          </p:grpSpPr>
          <p:sp>
            <p:nvSpPr>
              <p:cNvPr id="255" name=""/>
              <p:cNvSpPr/>
              <p:nvPr/>
            </p:nvSpPr>
            <p:spPr>
              <a:xfrm>
                <a:off x="2590920" y="5487840"/>
                <a:ext cx="1822320" cy="1457640"/>
              </a:xfrm>
              <a:custGeom>
                <a:avLst/>
                <a:gdLst/>
                <a:ahLst/>
                <a:rect l="l" t="t" r="r" b="b"/>
                <a:pathLst>
                  <a:path w="1148" h="918">
                    <a:moveTo>
                      <a:pt x="1148" y="918"/>
                    </a:moveTo>
                    <a:lnTo>
                      <a:pt x="0" y="0"/>
                    </a:lnTo>
                    <a:lnTo>
                      <a:pt x="0" y="918"/>
                    </a:lnTo>
                    <a:lnTo>
                      <a:pt x="1148" y="918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>
                <a:off x="2590920" y="5487840"/>
                <a:ext cx="1822320" cy="1457640"/>
              </a:xfrm>
              <a:custGeom>
                <a:avLst/>
                <a:gdLst/>
                <a:ahLst/>
                <a:rect l="l" t="t" r="r" b="b"/>
                <a:pathLst>
                  <a:path w="1148" h="918">
                    <a:moveTo>
                      <a:pt x="0" y="0"/>
                    </a:moveTo>
                    <a:lnTo>
                      <a:pt x="1148" y="0"/>
                    </a:lnTo>
                    <a:lnTo>
                      <a:pt x="1148" y="91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>
                <a:off x="2590920" y="5487840"/>
                <a:ext cx="1822320" cy="1457640"/>
              </a:xfrm>
              <a:custGeom>
                <a:avLst/>
                <a:gdLst/>
                <a:ahLst/>
                <a:rect l="l" t="t" r="r" b="b"/>
                <a:pathLst>
                  <a:path w="1148" h="918">
                    <a:moveTo>
                      <a:pt x="1148" y="918"/>
                    </a:moveTo>
                    <a:lnTo>
                      <a:pt x="0" y="0"/>
                    </a:lnTo>
                    <a:lnTo>
                      <a:pt x="0" y="918"/>
                    </a:lnTo>
                    <a:lnTo>
                      <a:pt x="1148" y="918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2590920" y="5487840"/>
                <a:ext cx="1822320" cy="1457640"/>
              </a:xfrm>
              <a:custGeom>
                <a:avLst/>
                <a:gdLst/>
                <a:ahLst/>
                <a:rect l="l" t="t" r="r" b="b"/>
                <a:pathLst>
                  <a:path w="1148" h="918">
                    <a:moveTo>
                      <a:pt x="0" y="0"/>
                    </a:moveTo>
                    <a:lnTo>
                      <a:pt x="1148" y="0"/>
                    </a:lnTo>
                    <a:lnTo>
                      <a:pt x="1148" y="91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>
                <a:off x="3470400" y="6850080"/>
                <a:ext cx="21708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RAR beta</a:t>
                </a:r>
                <a:endParaRPr b="0" lang="en-US" sz="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>
                <a:off x="4334040" y="672480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>
                <a:off x="4078440" y="672480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3836160" y="672480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>
                <a:off x="3585600" y="672480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3334680" y="672480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>
                <a:off x="3083760" y="672480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2828160" y="672480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 rot="16200000">
                <a:off x="2584080" y="6059160"/>
                <a:ext cx="25812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PPAR delta</a:t>
                </a:r>
                <a:endParaRPr b="0" lang="en-US" sz="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2795040" y="55371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2795040" y="57657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2795040" y="59943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>
                <a:off x="2795040" y="6222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2795040" y="645012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>
                <a:off x="2795040" y="665964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4340160" y="6711840"/>
                <a:ext cx="180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4089240" y="6711840"/>
                <a:ext cx="180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3838680" y="671184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>
                <a:off x="3583080" y="671184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3332160" y="671184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3081240" y="6711840"/>
                <a:ext cx="180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2830680" y="671184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2819520" y="5560920"/>
                <a:ext cx="111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2819520" y="5788080"/>
                <a:ext cx="1116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2819520" y="6019920"/>
                <a:ext cx="1116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2819520" y="6248520"/>
                <a:ext cx="1116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2819520" y="6480000"/>
                <a:ext cx="111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>
                <a:off x="2819520" y="6708600"/>
                <a:ext cx="111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>
                <a:off x="2830680" y="5560920"/>
                <a:ext cx="1509480" cy="1147680"/>
              </a:xfrm>
              <a:custGeom>
                <a:avLst/>
                <a:gdLst/>
                <a:ahLst/>
                <a:rect l="l" t="t" r="r" b="b"/>
                <a:pathLst>
                  <a:path w="951" h="723">
                    <a:moveTo>
                      <a:pt x="951" y="723"/>
                    </a:moveTo>
                    <a:lnTo>
                      <a:pt x="0" y="0"/>
                    </a:lnTo>
                    <a:lnTo>
                      <a:pt x="0" y="723"/>
                    </a:lnTo>
                    <a:lnTo>
                      <a:pt x="951" y="723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2830680" y="5560920"/>
                <a:ext cx="1509480" cy="1147680"/>
              </a:xfrm>
              <a:custGeom>
                <a:avLst/>
                <a:gdLst/>
                <a:ahLst/>
                <a:rect l="l" t="t" r="r" b="b"/>
                <a:pathLst>
                  <a:path w="951" h="723">
                    <a:moveTo>
                      <a:pt x="0" y="0"/>
                    </a:moveTo>
                    <a:lnTo>
                      <a:pt x="951" y="0"/>
                    </a:lnTo>
                    <a:lnTo>
                      <a:pt x="951" y="72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>
                <a:off x="2830680" y="5560920"/>
                <a:ext cx="1509480" cy="114768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>
                <a:off x="3198960" y="556092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3035160" y="63514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>
                <a:off x="2986200" y="65944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>
                <a:off x="3670200" y="60660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2948040" y="64738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>
                <a:off x="3165480" y="636264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3024360" y="62722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3252960" y="635472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2860560" y="650412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>
                <a:off x="2846520" y="647388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3040200" y="634356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3005280" y="64008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3016080" y="6572160"/>
                <a:ext cx="162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>
                <a:off x="2933640" y="622620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3294000" y="59101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>
                <a:off x="2990880" y="642780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>
                <a:off x="3089160" y="633564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>
                <a:off x="3040200" y="629748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>
                <a:off x="3005280" y="640404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>
                <a:off x="3173400" y="622152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3309840" y="571176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>
                <a:off x="3097080" y="640404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>
                <a:off x="3035160" y="65563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>
                <a:off x="3689280" y="596736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>
                <a:off x="2898720" y="629136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>
                <a:off x="2901960" y="640872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3222720" y="599760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>
                <a:off x="3664080" y="624528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>
                <a:off x="2887560" y="643104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>
                <a:off x="2882880" y="643104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3282840" y="645480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>
                <a:off x="3340080" y="63817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2990880" y="641988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>
                <a:off x="3206880" y="623412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3522600" y="56707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2948040" y="615780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3187800" y="6278400"/>
                <a:ext cx="1584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3274920" y="632160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3321000" y="64612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>
                <a:off x="3629160" y="622944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3629160" y="568656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2990880" y="647388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3070080" y="661032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>
                <a:off x="3890880" y="6076800"/>
                <a:ext cx="1584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2940120" y="645804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2921040" y="641196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3340080" y="630252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>
                <a:off x="4184640" y="632772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>
                <a:off x="2852640" y="64882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2901960" y="649296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3449520" y="64198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3405240" y="637056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3097080" y="655308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3032280" y="62946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3255840" y="588816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>
                <a:off x="3100320" y="641664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3165480" y="632448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3309840" y="627552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>
                <a:off x="3233880" y="632448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>
                <a:off x="3683160" y="6264360"/>
                <a:ext cx="140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 flipV="1">
                <a:off x="3587760" y="5868720"/>
                <a:ext cx="752400" cy="28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 flipV="1">
                <a:off x="2830680" y="6152760"/>
                <a:ext cx="757080" cy="2890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2830680" y="6708600"/>
                <a:ext cx="150948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 flipV="1">
                <a:off x="2830680" y="5560920"/>
                <a:ext cx="1440" cy="11476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>
                <a:off x="4001400" y="5648400"/>
                <a:ext cx="1836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CC : 0.571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>
                <a:off x="3998880" y="5716440"/>
                <a:ext cx="1728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p : &lt;0.001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356" name=""/>
            <p:cNvGrpSpPr/>
            <p:nvPr/>
          </p:nvGrpSpPr>
          <p:grpSpPr>
            <a:xfrm>
              <a:off x="2590920" y="7080120"/>
              <a:ext cx="1825560" cy="1460520"/>
              <a:chOff x="2590920" y="7080120"/>
              <a:chExt cx="1825560" cy="1460520"/>
            </a:xfrm>
          </p:grpSpPr>
          <p:sp>
            <p:nvSpPr>
              <p:cNvPr id="357" name=""/>
              <p:cNvSpPr/>
              <p:nvPr/>
            </p:nvSpPr>
            <p:spPr>
              <a:xfrm>
                <a:off x="2590920" y="7080120"/>
                <a:ext cx="1825560" cy="1460520"/>
              </a:xfrm>
              <a:custGeom>
                <a:avLst/>
                <a:gdLst/>
                <a:ahLst/>
                <a:rect l="l" t="t" r="r" b="b"/>
                <a:pathLst>
                  <a:path w="1150" h="920">
                    <a:moveTo>
                      <a:pt x="1150" y="920"/>
                    </a:moveTo>
                    <a:lnTo>
                      <a:pt x="0" y="0"/>
                    </a:lnTo>
                    <a:lnTo>
                      <a:pt x="0" y="920"/>
                    </a:lnTo>
                    <a:lnTo>
                      <a:pt x="1150" y="92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>
                <a:off x="2590920" y="7080120"/>
                <a:ext cx="1825560" cy="1460520"/>
              </a:xfrm>
              <a:custGeom>
                <a:avLst/>
                <a:gdLst/>
                <a:ahLst/>
                <a:rect l="l" t="t" r="r" b="b"/>
                <a:pathLst>
                  <a:path w="1150" h="920">
                    <a:moveTo>
                      <a:pt x="0" y="0"/>
                    </a:moveTo>
                    <a:lnTo>
                      <a:pt x="1150" y="0"/>
                    </a:lnTo>
                    <a:lnTo>
                      <a:pt x="1150" y="92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>
                <a:off x="2590920" y="7080120"/>
                <a:ext cx="1825560" cy="1460520"/>
              </a:xfrm>
              <a:custGeom>
                <a:avLst/>
                <a:gdLst/>
                <a:ahLst/>
                <a:rect l="l" t="t" r="r" b="b"/>
                <a:pathLst>
                  <a:path w="1150" h="920">
                    <a:moveTo>
                      <a:pt x="1150" y="920"/>
                    </a:moveTo>
                    <a:lnTo>
                      <a:pt x="0" y="0"/>
                    </a:lnTo>
                    <a:lnTo>
                      <a:pt x="0" y="920"/>
                    </a:lnTo>
                    <a:lnTo>
                      <a:pt x="1150" y="92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>
                <a:off x="2590920" y="7080120"/>
                <a:ext cx="1825560" cy="1460520"/>
              </a:xfrm>
              <a:custGeom>
                <a:avLst/>
                <a:gdLst/>
                <a:ahLst/>
                <a:rect l="l" t="t" r="r" b="b"/>
                <a:pathLst>
                  <a:path w="1150" h="920">
                    <a:moveTo>
                      <a:pt x="0" y="0"/>
                    </a:moveTo>
                    <a:lnTo>
                      <a:pt x="1150" y="0"/>
                    </a:lnTo>
                    <a:lnTo>
                      <a:pt x="1150" y="92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>
                <a:off x="3510720" y="8445600"/>
                <a:ext cx="28584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RAR gamma</a:t>
                </a:r>
                <a:endParaRPr b="0" lang="en-US" sz="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>
                <a:off x="4337280" y="831996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>
                <a:off x="4150080" y="831996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>
                <a:off x="3962880" y="831996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>
                <a:off x="3777120" y="831996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>
                <a:off x="3598200" y="8319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>
                <a:off x="3412440" y="8319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>
                <a:off x="3225240" y="8319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>
                <a:off x="3039480" y="8319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>
                <a:off x="2851920" y="8319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 rot="16200000">
                <a:off x="2601720" y="7704000"/>
                <a:ext cx="21708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RAR beta</a:t>
                </a:r>
                <a:endParaRPr b="0" lang="en-US" sz="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>
                <a:off x="2797560" y="712944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>
                <a:off x="2797560" y="731988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>
                <a:off x="2817000" y="751212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>
                <a:off x="2817000" y="77025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2817000" y="789300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2817000" y="808344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2817000" y="82551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>
                <a:off x="4343400" y="830736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4156200" y="830736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>
                <a:off x="3970440" y="830736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>
                <a:off x="3782880" y="8307360"/>
                <a:ext cx="180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>
                <a:off x="3597120" y="8307360"/>
                <a:ext cx="180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>
                <a:off x="3413160" y="830736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>
                <a:off x="3227400" y="830736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3040200" y="830736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>
                <a:off x="2854440" y="8307360"/>
                <a:ext cx="144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>
                <a:off x="2841480" y="7153200"/>
                <a:ext cx="129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>
                <a:off x="2841480" y="7343640"/>
                <a:ext cx="129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2841480" y="7537320"/>
                <a:ext cx="129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>
                <a:off x="2841480" y="7728120"/>
                <a:ext cx="1296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2841480" y="7918560"/>
                <a:ext cx="1296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>
                <a:off x="2841480" y="8113680"/>
                <a:ext cx="129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2841480" y="8304120"/>
                <a:ext cx="129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>
                <a:off x="2854440" y="7153200"/>
                <a:ext cx="1488960" cy="1150920"/>
              </a:xfrm>
              <a:custGeom>
                <a:avLst/>
                <a:gdLst/>
                <a:ahLst/>
                <a:rect l="l" t="t" r="r" b="b"/>
                <a:pathLst>
                  <a:path w="938" h="725">
                    <a:moveTo>
                      <a:pt x="938" y="725"/>
                    </a:moveTo>
                    <a:lnTo>
                      <a:pt x="0" y="0"/>
                    </a:lnTo>
                    <a:lnTo>
                      <a:pt x="0" y="725"/>
                    </a:lnTo>
                    <a:lnTo>
                      <a:pt x="938" y="725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>
                <a:off x="2854440" y="7153200"/>
                <a:ext cx="1488960" cy="1150920"/>
              </a:xfrm>
              <a:custGeom>
                <a:avLst/>
                <a:gdLst/>
                <a:ahLst/>
                <a:rect l="l" t="t" r="r" b="b"/>
                <a:pathLst>
                  <a:path w="938" h="725">
                    <a:moveTo>
                      <a:pt x="0" y="0"/>
                    </a:moveTo>
                    <a:lnTo>
                      <a:pt x="938" y="0"/>
                    </a:lnTo>
                    <a:lnTo>
                      <a:pt x="938" y="72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>
                <a:off x="2854440" y="7153200"/>
                <a:ext cx="1488960" cy="115092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3463920" y="800568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>
                <a:off x="2944800" y="813276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>
                <a:off x="3051000" y="8170920"/>
                <a:ext cx="162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>
                <a:off x="3387600" y="764856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>
                <a:off x="3139920" y="820116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>
                <a:off x="2979720" y="803736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3978360" y="814392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>
                <a:off x="3592440" y="79675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3002040" y="826596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>
                <a:off x="3051000" y="827712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>
                <a:off x="3448080" y="813276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>
                <a:off x="3603600" y="81550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>
                <a:off x="3219480" y="814716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>
                <a:off x="3181320" y="8211960"/>
                <a:ext cx="1584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>
                <a:off x="4179960" y="793764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>
                <a:off x="3265560" y="817092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>
                <a:off x="3763800" y="8094600"/>
                <a:ext cx="162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>
                <a:off x="3216240" y="813276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>
                <a:off x="3025800" y="815976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>
                <a:off x="3371760" y="802944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>
                <a:off x="3494160" y="792648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>
                <a:off x="3013200" y="80866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>
                <a:off x="3036960" y="813276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>
                <a:off x="3502080" y="763272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>
                <a:off x="3254400" y="8238960"/>
                <a:ext cx="1440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>
                <a:off x="2994120" y="823608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>
                <a:off x="4313160" y="7991640"/>
                <a:ext cx="144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>
                <a:off x="3516480" y="76564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2963880" y="824724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>
                <a:off x="3059280" y="82501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3741840" y="794556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>
                <a:off x="3749760" y="790416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>
                <a:off x="3417840" y="817092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>
                <a:off x="3159000" y="8002440"/>
                <a:ext cx="1440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>
                <a:off x="4275000" y="7763040"/>
                <a:ext cx="144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>
                <a:off x="3333600" y="820116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4" name=""/>
              <p:cNvSpPr/>
              <p:nvPr/>
            </p:nvSpPr>
            <p:spPr>
              <a:xfrm>
                <a:off x="3828960" y="801864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5" name=""/>
              <p:cNvSpPr/>
              <p:nvPr/>
            </p:nvSpPr>
            <p:spPr>
              <a:xfrm>
                <a:off x="3311640" y="7948440"/>
                <a:ext cx="1404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6" name=""/>
              <p:cNvSpPr/>
              <p:nvPr/>
            </p:nvSpPr>
            <p:spPr>
              <a:xfrm>
                <a:off x="3056040" y="791856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7" name=""/>
              <p:cNvSpPr/>
              <p:nvPr/>
            </p:nvSpPr>
            <p:spPr>
              <a:xfrm>
                <a:off x="3344760" y="768204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8" name=""/>
              <p:cNvSpPr/>
              <p:nvPr/>
            </p:nvSpPr>
            <p:spPr>
              <a:xfrm>
                <a:off x="3181320" y="76788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39" name=""/>
              <p:cNvSpPr/>
              <p:nvPr/>
            </p:nvSpPr>
            <p:spPr>
              <a:xfrm>
                <a:off x="2968560" y="817092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0" name=""/>
              <p:cNvSpPr/>
              <p:nvPr/>
            </p:nvSpPr>
            <p:spPr>
              <a:xfrm>
                <a:off x="2922480" y="810900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1" name=""/>
              <p:cNvSpPr/>
              <p:nvPr/>
            </p:nvSpPr>
            <p:spPr>
              <a:xfrm>
                <a:off x="3273480" y="748044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2" name=""/>
              <p:cNvSpPr/>
              <p:nvPr/>
            </p:nvSpPr>
            <p:spPr>
              <a:xfrm>
                <a:off x="3121200" y="8209080"/>
                <a:ext cx="140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3" name=""/>
              <p:cNvSpPr/>
              <p:nvPr/>
            </p:nvSpPr>
            <p:spPr>
              <a:xfrm>
                <a:off x="2971800" y="822024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4" name=""/>
              <p:cNvSpPr/>
              <p:nvPr/>
            </p:nvSpPr>
            <p:spPr>
              <a:xfrm>
                <a:off x="3143160" y="78994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5" name=""/>
              <p:cNvSpPr/>
              <p:nvPr/>
            </p:nvSpPr>
            <p:spPr>
              <a:xfrm>
                <a:off x="3159000" y="7259760"/>
                <a:ext cx="144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6" name=""/>
              <p:cNvSpPr/>
              <p:nvPr/>
            </p:nvSpPr>
            <p:spPr>
              <a:xfrm>
                <a:off x="3040200" y="82738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7" name=""/>
              <p:cNvSpPr/>
              <p:nvPr/>
            </p:nvSpPr>
            <p:spPr>
              <a:xfrm>
                <a:off x="2930400" y="8236080"/>
                <a:ext cx="144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8" name=""/>
              <p:cNvSpPr/>
              <p:nvPr/>
            </p:nvSpPr>
            <p:spPr>
              <a:xfrm>
                <a:off x="3070080" y="781524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9" name=""/>
              <p:cNvSpPr/>
              <p:nvPr/>
            </p:nvSpPr>
            <p:spPr>
              <a:xfrm>
                <a:off x="3105000" y="785340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0" name=""/>
              <p:cNvSpPr/>
              <p:nvPr/>
            </p:nvSpPr>
            <p:spPr>
              <a:xfrm>
                <a:off x="3135240" y="80866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1" name=""/>
              <p:cNvSpPr/>
              <p:nvPr/>
            </p:nvSpPr>
            <p:spPr>
              <a:xfrm>
                <a:off x="3040200" y="81360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2" name=""/>
              <p:cNvSpPr/>
              <p:nvPr/>
            </p:nvSpPr>
            <p:spPr>
              <a:xfrm>
                <a:off x="3508200" y="796464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3" name=""/>
              <p:cNvSpPr/>
              <p:nvPr/>
            </p:nvSpPr>
            <p:spPr>
              <a:xfrm>
                <a:off x="3094200" y="808200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4" name=""/>
              <p:cNvSpPr/>
              <p:nvPr/>
            </p:nvSpPr>
            <p:spPr>
              <a:xfrm>
                <a:off x="3170160" y="803268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5" name=""/>
              <p:cNvSpPr/>
              <p:nvPr/>
            </p:nvSpPr>
            <p:spPr>
              <a:xfrm>
                <a:off x="3159000" y="792648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6" name=""/>
              <p:cNvSpPr/>
              <p:nvPr/>
            </p:nvSpPr>
            <p:spPr>
              <a:xfrm>
                <a:off x="2963880" y="7983360"/>
                <a:ext cx="1584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7" name=""/>
              <p:cNvSpPr/>
              <p:nvPr/>
            </p:nvSpPr>
            <p:spPr>
              <a:xfrm>
                <a:off x="3097080" y="764064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8" name=""/>
              <p:cNvSpPr/>
              <p:nvPr/>
            </p:nvSpPr>
            <p:spPr>
              <a:xfrm flipV="1">
                <a:off x="3597120" y="7853040"/>
                <a:ext cx="746280" cy="122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9" name=""/>
              <p:cNvSpPr/>
              <p:nvPr/>
            </p:nvSpPr>
            <p:spPr>
              <a:xfrm flipV="1">
                <a:off x="2854440" y="7975440"/>
                <a:ext cx="742680" cy="122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0" name=""/>
              <p:cNvSpPr/>
              <p:nvPr/>
            </p:nvSpPr>
            <p:spPr>
              <a:xfrm>
                <a:off x="2854440" y="8304120"/>
                <a:ext cx="14889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1" name=""/>
              <p:cNvSpPr/>
              <p:nvPr/>
            </p:nvSpPr>
            <p:spPr>
              <a:xfrm flipV="1">
                <a:off x="2854440" y="7152840"/>
                <a:ext cx="1440" cy="1150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2" name=""/>
              <p:cNvSpPr/>
              <p:nvPr/>
            </p:nvSpPr>
            <p:spPr>
              <a:xfrm>
                <a:off x="4007880" y="7316640"/>
                <a:ext cx="1836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CC : 0.43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3" name=""/>
              <p:cNvSpPr/>
              <p:nvPr/>
            </p:nvSpPr>
            <p:spPr>
              <a:xfrm>
                <a:off x="4001760" y="7373880"/>
                <a:ext cx="15012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p : 0.001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464" name=""/>
            <p:cNvGrpSpPr/>
            <p:nvPr/>
          </p:nvGrpSpPr>
          <p:grpSpPr>
            <a:xfrm>
              <a:off x="4495680" y="7058160"/>
              <a:ext cx="1817640" cy="1455480"/>
              <a:chOff x="4495680" y="7058160"/>
              <a:chExt cx="1817640" cy="1455480"/>
            </a:xfrm>
          </p:grpSpPr>
          <p:sp>
            <p:nvSpPr>
              <p:cNvPr id="465" name=""/>
              <p:cNvSpPr/>
              <p:nvPr/>
            </p:nvSpPr>
            <p:spPr>
              <a:xfrm>
                <a:off x="4495680" y="7058160"/>
                <a:ext cx="1817640" cy="1455480"/>
              </a:xfrm>
              <a:custGeom>
                <a:avLst/>
                <a:gdLst/>
                <a:ahLst/>
                <a:rect l="l" t="t" r="r" b="b"/>
                <a:pathLst>
                  <a:path w="1145" h="917">
                    <a:moveTo>
                      <a:pt x="1145" y="917"/>
                    </a:moveTo>
                    <a:lnTo>
                      <a:pt x="0" y="0"/>
                    </a:lnTo>
                    <a:lnTo>
                      <a:pt x="0" y="917"/>
                    </a:lnTo>
                    <a:lnTo>
                      <a:pt x="1145" y="917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6" name=""/>
              <p:cNvSpPr/>
              <p:nvPr/>
            </p:nvSpPr>
            <p:spPr>
              <a:xfrm>
                <a:off x="4495680" y="7058160"/>
                <a:ext cx="1817640" cy="1455480"/>
              </a:xfrm>
              <a:custGeom>
                <a:avLst/>
                <a:gdLst/>
                <a:ahLst/>
                <a:rect l="l" t="t" r="r" b="b"/>
                <a:pathLst>
                  <a:path w="1145" h="917">
                    <a:moveTo>
                      <a:pt x="0" y="0"/>
                    </a:moveTo>
                    <a:lnTo>
                      <a:pt x="1145" y="0"/>
                    </a:lnTo>
                    <a:lnTo>
                      <a:pt x="1145" y="91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7" name=""/>
              <p:cNvSpPr/>
              <p:nvPr/>
            </p:nvSpPr>
            <p:spPr>
              <a:xfrm>
                <a:off x="4495680" y="7058160"/>
                <a:ext cx="1817640" cy="1455480"/>
              </a:xfrm>
              <a:custGeom>
                <a:avLst/>
                <a:gdLst/>
                <a:ahLst/>
                <a:rect l="l" t="t" r="r" b="b"/>
                <a:pathLst>
                  <a:path w="1145" h="917">
                    <a:moveTo>
                      <a:pt x="1145" y="917"/>
                    </a:moveTo>
                    <a:lnTo>
                      <a:pt x="0" y="0"/>
                    </a:lnTo>
                    <a:lnTo>
                      <a:pt x="0" y="917"/>
                    </a:lnTo>
                    <a:lnTo>
                      <a:pt x="1145" y="917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8" name=""/>
              <p:cNvSpPr/>
              <p:nvPr/>
            </p:nvSpPr>
            <p:spPr>
              <a:xfrm>
                <a:off x="4495680" y="7058160"/>
                <a:ext cx="1817640" cy="1455480"/>
              </a:xfrm>
              <a:custGeom>
                <a:avLst/>
                <a:gdLst/>
                <a:ahLst/>
                <a:rect l="l" t="t" r="r" b="b"/>
                <a:pathLst>
                  <a:path w="1145" h="917">
                    <a:moveTo>
                      <a:pt x="0" y="0"/>
                    </a:moveTo>
                    <a:lnTo>
                      <a:pt x="1145" y="0"/>
                    </a:lnTo>
                    <a:lnTo>
                      <a:pt x="1145" y="91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9" name=""/>
              <p:cNvSpPr/>
              <p:nvPr/>
            </p:nvSpPr>
            <p:spPr>
              <a:xfrm>
                <a:off x="5373720" y="8418600"/>
                <a:ext cx="21708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RAR beta</a:t>
                </a:r>
                <a:endParaRPr b="0" lang="en-US" sz="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0" name=""/>
              <p:cNvSpPr/>
              <p:nvPr/>
            </p:nvSpPr>
            <p:spPr>
              <a:xfrm>
                <a:off x="6234480" y="829296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1" name=""/>
              <p:cNvSpPr/>
              <p:nvPr/>
            </p:nvSpPr>
            <p:spPr>
              <a:xfrm>
                <a:off x="5980320" y="8292960"/>
                <a:ext cx="435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2" name=""/>
              <p:cNvSpPr/>
              <p:nvPr/>
            </p:nvSpPr>
            <p:spPr>
              <a:xfrm>
                <a:off x="5738040" y="8292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3" name=""/>
              <p:cNvSpPr/>
              <p:nvPr/>
            </p:nvSpPr>
            <p:spPr>
              <a:xfrm>
                <a:off x="5488920" y="8292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4" name=""/>
              <p:cNvSpPr/>
              <p:nvPr/>
            </p:nvSpPr>
            <p:spPr>
              <a:xfrm>
                <a:off x="5238000" y="8292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5" name=""/>
              <p:cNvSpPr/>
              <p:nvPr/>
            </p:nvSpPr>
            <p:spPr>
              <a:xfrm>
                <a:off x="4987080" y="8292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6" name=""/>
              <p:cNvSpPr/>
              <p:nvPr/>
            </p:nvSpPr>
            <p:spPr>
              <a:xfrm>
                <a:off x="4733280" y="8292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7" name=""/>
              <p:cNvSpPr/>
              <p:nvPr/>
            </p:nvSpPr>
            <p:spPr>
              <a:xfrm rot="16200000">
                <a:off x="4497480" y="7626960"/>
                <a:ext cx="24156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RXR alpha</a:t>
                </a:r>
                <a:endParaRPr b="0" lang="en-US" sz="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8" name=""/>
              <p:cNvSpPr/>
              <p:nvPr/>
            </p:nvSpPr>
            <p:spPr>
              <a:xfrm>
                <a:off x="4698360" y="710712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9" name=""/>
              <p:cNvSpPr/>
              <p:nvPr/>
            </p:nvSpPr>
            <p:spPr>
              <a:xfrm>
                <a:off x="4698360" y="73929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0" name=""/>
              <p:cNvSpPr/>
              <p:nvPr/>
            </p:nvSpPr>
            <p:spPr>
              <a:xfrm>
                <a:off x="4698360" y="767700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1" name=""/>
              <p:cNvSpPr/>
              <p:nvPr/>
            </p:nvSpPr>
            <p:spPr>
              <a:xfrm>
                <a:off x="4698360" y="796284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2" name=""/>
              <p:cNvSpPr/>
              <p:nvPr/>
            </p:nvSpPr>
            <p:spPr>
              <a:xfrm>
                <a:off x="4698360" y="8228160"/>
                <a:ext cx="2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3" name=""/>
              <p:cNvSpPr/>
              <p:nvPr/>
            </p:nvSpPr>
            <p:spPr>
              <a:xfrm>
                <a:off x="6240600" y="8282160"/>
                <a:ext cx="1440" cy="6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4" name=""/>
              <p:cNvSpPr/>
              <p:nvPr/>
            </p:nvSpPr>
            <p:spPr>
              <a:xfrm>
                <a:off x="5991120" y="8282160"/>
                <a:ext cx="1800" cy="6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5" name=""/>
              <p:cNvSpPr/>
              <p:nvPr/>
            </p:nvSpPr>
            <p:spPr>
              <a:xfrm>
                <a:off x="5740560" y="8282160"/>
                <a:ext cx="1440" cy="6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6" name=""/>
              <p:cNvSpPr/>
              <p:nvPr/>
            </p:nvSpPr>
            <p:spPr>
              <a:xfrm>
                <a:off x="5486400" y="8282160"/>
                <a:ext cx="1440" cy="6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7" name=""/>
              <p:cNvSpPr/>
              <p:nvPr/>
            </p:nvSpPr>
            <p:spPr>
              <a:xfrm>
                <a:off x="5235480" y="8282160"/>
                <a:ext cx="1800" cy="6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8" name=""/>
              <p:cNvSpPr/>
              <p:nvPr/>
            </p:nvSpPr>
            <p:spPr>
              <a:xfrm>
                <a:off x="4984920" y="8282160"/>
                <a:ext cx="1440" cy="6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9" name=""/>
              <p:cNvSpPr/>
              <p:nvPr/>
            </p:nvSpPr>
            <p:spPr>
              <a:xfrm>
                <a:off x="4735440" y="8282160"/>
                <a:ext cx="1800" cy="6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0" name=""/>
              <p:cNvSpPr/>
              <p:nvPr/>
            </p:nvSpPr>
            <p:spPr>
              <a:xfrm>
                <a:off x="4722840" y="7129440"/>
                <a:ext cx="1260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1" name=""/>
              <p:cNvSpPr/>
              <p:nvPr/>
            </p:nvSpPr>
            <p:spPr>
              <a:xfrm>
                <a:off x="4722840" y="7415280"/>
                <a:ext cx="1260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2" name=""/>
              <p:cNvSpPr/>
              <p:nvPr/>
            </p:nvSpPr>
            <p:spPr>
              <a:xfrm>
                <a:off x="4722840" y="7704000"/>
                <a:ext cx="1260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3" name=""/>
              <p:cNvSpPr/>
              <p:nvPr/>
            </p:nvSpPr>
            <p:spPr>
              <a:xfrm>
                <a:off x="4722840" y="7993080"/>
                <a:ext cx="12600" cy="1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4" name=""/>
              <p:cNvSpPr/>
              <p:nvPr/>
            </p:nvSpPr>
            <p:spPr>
              <a:xfrm>
                <a:off x="4722840" y="8277120"/>
                <a:ext cx="1260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5" name=""/>
              <p:cNvSpPr/>
              <p:nvPr/>
            </p:nvSpPr>
            <p:spPr>
              <a:xfrm>
                <a:off x="4735440" y="7129440"/>
                <a:ext cx="1505160" cy="1147680"/>
              </a:xfrm>
              <a:custGeom>
                <a:avLst/>
                <a:gdLst/>
                <a:ahLst/>
                <a:rect l="l" t="t" r="r" b="b"/>
                <a:pathLst>
                  <a:path w="948" h="723">
                    <a:moveTo>
                      <a:pt x="948" y="723"/>
                    </a:moveTo>
                    <a:lnTo>
                      <a:pt x="0" y="0"/>
                    </a:lnTo>
                    <a:lnTo>
                      <a:pt x="0" y="723"/>
                    </a:lnTo>
                    <a:lnTo>
                      <a:pt x="948" y="723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6" name=""/>
              <p:cNvSpPr/>
              <p:nvPr/>
            </p:nvSpPr>
            <p:spPr>
              <a:xfrm>
                <a:off x="4735440" y="7129440"/>
                <a:ext cx="1505160" cy="1147680"/>
              </a:xfrm>
              <a:custGeom>
                <a:avLst/>
                <a:gdLst/>
                <a:ahLst/>
                <a:rect l="l" t="t" r="r" b="b"/>
                <a:pathLst>
                  <a:path w="948" h="723">
                    <a:moveTo>
                      <a:pt x="0" y="0"/>
                    </a:moveTo>
                    <a:lnTo>
                      <a:pt x="948" y="0"/>
                    </a:lnTo>
                    <a:lnTo>
                      <a:pt x="948" y="72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7" name=""/>
              <p:cNvSpPr/>
              <p:nvPr/>
            </p:nvSpPr>
            <p:spPr>
              <a:xfrm>
                <a:off x="4735440" y="7129440"/>
                <a:ext cx="1505160" cy="114768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8" name=""/>
              <p:cNvSpPr/>
              <p:nvPr/>
            </p:nvSpPr>
            <p:spPr>
              <a:xfrm>
                <a:off x="5102280" y="78217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9" name=""/>
              <p:cNvSpPr/>
              <p:nvPr/>
            </p:nvSpPr>
            <p:spPr>
              <a:xfrm>
                <a:off x="4940280" y="802656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0" name=""/>
              <p:cNvSpPr/>
              <p:nvPr/>
            </p:nvSpPr>
            <p:spPr>
              <a:xfrm>
                <a:off x="4890960" y="819468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1" name=""/>
              <p:cNvSpPr/>
              <p:nvPr/>
            </p:nvSpPr>
            <p:spPr>
              <a:xfrm>
                <a:off x="5573880" y="788976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2" name=""/>
              <p:cNvSpPr/>
              <p:nvPr/>
            </p:nvSpPr>
            <p:spPr>
              <a:xfrm>
                <a:off x="4853160" y="815976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3" name=""/>
              <p:cNvSpPr/>
              <p:nvPr/>
            </p:nvSpPr>
            <p:spPr>
              <a:xfrm>
                <a:off x="5068800" y="820116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4" name=""/>
              <p:cNvSpPr/>
              <p:nvPr/>
            </p:nvSpPr>
            <p:spPr>
              <a:xfrm>
                <a:off x="4927680" y="81262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5" name=""/>
              <p:cNvSpPr/>
              <p:nvPr/>
            </p:nvSpPr>
            <p:spPr>
              <a:xfrm>
                <a:off x="5156280" y="810252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6" name=""/>
              <p:cNvSpPr/>
              <p:nvPr/>
            </p:nvSpPr>
            <p:spPr>
              <a:xfrm>
                <a:off x="4765680" y="8045280"/>
                <a:ext cx="1440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7" name=""/>
              <p:cNvSpPr/>
              <p:nvPr/>
            </p:nvSpPr>
            <p:spPr>
              <a:xfrm>
                <a:off x="4749840" y="81136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8" name=""/>
              <p:cNvSpPr/>
              <p:nvPr/>
            </p:nvSpPr>
            <p:spPr>
              <a:xfrm>
                <a:off x="4943520" y="808848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9" name=""/>
              <p:cNvSpPr/>
              <p:nvPr/>
            </p:nvSpPr>
            <p:spPr>
              <a:xfrm>
                <a:off x="4908600" y="804240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0" name=""/>
              <p:cNvSpPr/>
              <p:nvPr/>
            </p:nvSpPr>
            <p:spPr>
              <a:xfrm>
                <a:off x="4921200" y="8061480"/>
                <a:ext cx="144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1" name=""/>
              <p:cNvSpPr/>
              <p:nvPr/>
            </p:nvSpPr>
            <p:spPr>
              <a:xfrm>
                <a:off x="4836960" y="7993080"/>
                <a:ext cx="162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2" name=""/>
              <p:cNvSpPr/>
              <p:nvPr/>
            </p:nvSpPr>
            <p:spPr>
              <a:xfrm>
                <a:off x="5197320" y="7480440"/>
                <a:ext cx="162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3" name=""/>
              <p:cNvSpPr/>
              <p:nvPr/>
            </p:nvSpPr>
            <p:spPr>
              <a:xfrm>
                <a:off x="4894200" y="798192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4" name=""/>
              <p:cNvSpPr/>
              <p:nvPr/>
            </p:nvSpPr>
            <p:spPr>
              <a:xfrm>
                <a:off x="4992840" y="79884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5" name=""/>
              <p:cNvSpPr/>
              <p:nvPr/>
            </p:nvSpPr>
            <p:spPr>
              <a:xfrm>
                <a:off x="4943520" y="790560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6" name=""/>
              <p:cNvSpPr/>
              <p:nvPr/>
            </p:nvSpPr>
            <p:spPr>
              <a:xfrm>
                <a:off x="4908600" y="80074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7" name=""/>
              <p:cNvSpPr/>
              <p:nvPr/>
            </p:nvSpPr>
            <p:spPr>
              <a:xfrm>
                <a:off x="5076720" y="796932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8" name=""/>
              <p:cNvSpPr/>
              <p:nvPr/>
            </p:nvSpPr>
            <p:spPr>
              <a:xfrm>
                <a:off x="5213520" y="774216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9" name=""/>
              <p:cNvSpPr/>
              <p:nvPr/>
            </p:nvSpPr>
            <p:spPr>
              <a:xfrm>
                <a:off x="5000760" y="795492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0" name=""/>
              <p:cNvSpPr/>
              <p:nvPr/>
            </p:nvSpPr>
            <p:spPr>
              <a:xfrm>
                <a:off x="4940280" y="820584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1" name=""/>
              <p:cNvSpPr/>
              <p:nvPr/>
            </p:nvSpPr>
            <p:spPr>
              <a:xfrm>
                <a:off x="5592600" y="779472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2" name=""/>
              <p:cNvSpPr/>
              <p:nvPr/>
            </p:nvSpPr>
            <p:spPr>
              <a:xfrm>
                <a:off x="4803840" y="811044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3" name=""/>
              <p:cNvSpPr/>
              <p:nvPr/>
            </p:nvSpPr>
            <p:spPr>
              <a:xfrm>
                <a:off x="4807080" y="81900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4" name=""/>
              <p:cNvSpPr/>
              <p:nvPr/>
            </p:nvSpPr>
            <p:spPr>
              <a:xfrm>
                <a:off x="5126040" y="8050320"/>
                <a:ext cx="144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5" name=""/>
              <p:cNvSpPr/>
              <p:nvPr/>
            </p:nvSpPr>
            <p:spPr>
              <a:xfrm>
                <a:off x="5565600" y="802656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6" name=""/>
              <p:cNvSpPr/>
              <p:nvPr/>
            </p:nvSpPr>
            <p:spPr>
              <a:xfrm>
                <a:off x="4791240" y="795024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7" name=""/>
              <p:cNvSpPr/>
              <p:nvPr/>
            </p:nvSpPr>
            <p:spPr>
              <a:xfrm>
                <a:off x="4788000" y="79963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8" name=""/>
              <p:cNvSpPr/>
              <p:nvPr/>
            </p:nvSpPr>
            <p:spPr>
              <a:xfrm>
                <a:off x="5186520" y="800100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9" name=""/>
              <p:cNvSpPr/>
              <p:nvPr/>
            </p:nvSpPr>
            <p:spPr>
              <a:xfrm>
                <a:off x="5243400" y="793584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0" name=""/>
              <p:cNvSpPr/>
              <p:nvPr/>
            </p:nvSpPr>
            <p:spPr>
              <a:xfrm>
                <a:off x="4894200" y="792000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1" name=""/>
              <p:cNvSpPr/>
              <p:nvPr/>
            </p:nvSpPr>
            <p:spPr>
              <a:xfrm>
                <a:off x="5110200" y="793584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2" name=""/>
              <p:cNvSpPr/>
              <p:nvPr/>
            </p:nvSpPr>
            <p:spPr>
              <a:xfrm>
                <a:off x="5424480" y="727092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3" name=""/>
              <p:cNvSpPr/>
              <p:nvPr/>
            </p:nvSpPr>
            <p:spPr>
              <a:xfrm>
                <a:off x="4853160" y="784080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4" name=""/>
              <p:cNvSpPr/>
              <p:nvPr/>
            </p:nvSpPr>
            <p:spPr>
              <a:xfrm>
                <a:off x="5091120" y="800100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5" name=""/>
              <p:cNvSpPr/>
              <p:nvPr/>
            </p:nvSpPr>
            <p:spPr>
              <a:xfrm>
                <a:off x="5178600" y="791676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6" name=""/>
              <p:cNvSpPr/>
              <p:nvPr/>
            </p:nvSpPr>
            <p:spPr>
              <a:xfrm>
                <a:off x="5224320" y="801540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7" name=""/>
              <p:cNvSpPr/>
              <p:nvPr/>
            </p:nvSpPr>
            <p:spPr>
              <a:xfrm>
                <a:off x="5530680" y="7875720"/>
                <a:ext cx="162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8" name=""/>
              <p:cNvSpPr/>
              <p:nvPr/>
            </p:nvSpPr>
            <p:spPr>
              <a:xfrm>
                <a:off x="5530680" y="7783560"/>
                <a:ext cx="162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9" name=""/>
              <p:cNvSpPr/>
              <p:nvPr/>
            </p:nvSpPr>
            <p:spPr>
              <a:xfrm>
                <a:off x="4894200" y="8088480"/>
                <a:ext cx="144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0" name=""/>
              <p:cNvSpPr/>
              <p:nvPr/>
            </p:nvSpPr>
            <p:spPr>
              <a:xfrm>
                <a:off x="4973760" y="820908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1" name=""/>
              <p:cNvSpPr/>
              <p:nvPr/>
            </p:nvSpPr>
            <p:spPr>
              <a:xfrm>
                <a:off x="5792760" y="780264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2" name=""/>
              <p:cNvSpPr/>
              <p:nvPr/>
            </p:nvSpPr>
            <p:spPr>
              <a:xfrm>
                <a:off x="4844880" y="812160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3" name=""/>
              <p:cNvSpPr/>
              <p:nvPr/>
            </p:nvSpPr>
            <p:spPr>
              <a:xfrm>
                <a:off x="4826160" y="819792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4" name=""/>
              <p:cNvSpPr/>
              <p:nvPr/>
            </p:nvSpPr>
            <p:spPr>
              <a:xfrm>
                <a:off x="5243400" y="814860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5" name=""/>
              <p:cNvSpPr/>
              <p:nvPr/>
            </p:nvSpPr>
            <p:spPr>
              <a:xfrm>
                <a:off x="6084720" y="8072280"/>
                <a:ext cx="16200" cy="162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6" name=""/>
              <p:cNvSpPr/>
              <p:nvPr/>
            </p:nvSpPr>
            <p:spPr>
              <a:xfrm>
                <a:off x="4757760" y="800424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7" name=""/>
              <p:cNvSpPr/>
              <p:nvPr/>
            </p:nvSpPr>
            <p:spPr>
              <a:xfrm>
                <a:off x="4807080" y="809928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8" name=""/>
              <p:cNvSpPr/>
              <p:nvPr/>
            </p:nvSpPr>
            <p:spPr>
              <a:xfrm>
                <a:off x="5353200" y="8023320"/>
                <a:ext cx="1584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9" name=""/>
              <p:cNvSpPr/>
              <p:nvPr/>
            </p:nvSpPr>
            <p:spPr>
              <a:xfrm>
                <a:off x="5307120" y="801216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0" name=""/>
              <p:cNvSpPr/>
              <p:nvPr/>
            </p:nvSpPr>
            <p:spPr>
              <a:xfrm>
                <a:off x="5000760" y="7958160"/>
                <a:ext cx="140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1" name=""/>
              <p:cNvSpPr/>
              <p:nvPr/>
            </p:nvSpPr>
            <p:spPr>
              <a:xfrm>
                <a:off x="4935600" y="7954920"/>
                <a:ext cx="158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2" name=""/>
              <p:cNvSpPr/>
              <p:nvPr/>
            </p:nvSpPr>
            <p:spPr>
              <a:xfrm>
                <a:off x="5159520" y="7464600"/>
                <a:ext cx="1584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3" name=""/>
              <p:cNvSpPr/>
              <p:nvPr/>
            </p:nvSpPr>
            <p:spPr>
              <a:xfrm>
                <a:off x="5003640" y="7886880"/>
                <a:ext cx="16200" cy="140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4" name=""/>
              <p:cNvSpPr/>
              <p:nvPr/>
            </p:nvSpPr>
            <p:spPr>
              <a:xfrm>
                <a:off x="5068800" y="7974000"/>
                <a:ext cx="1440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5" name=""/>
              <p:cNvSpPr/>
              <p:nvPr/>
            </p:nvSpPr>
            <p:spPr>
              <a:xfrm>
                <a:off x="5213520" y="7962840"/>
                <a:ext cx="14040" cy="144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6" name=""/>
              <p:cNvSpPr/>
              <p:nvPr/>
            </p:nvSpPr>
            <p:spPr>
              <a:xfrm>
                <a:off x="5137200" y="799632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7" name=""/>
              <p:cNvSpPr/>
              <p:nvPr/>
            </p:nvSpPr>
            <p:spPr>
              <a:xfrm>
                <a:off x="5584680" y="7985160"/>
                <a:ext cx="14400" cy="1584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8" name=""/>
              <p:cNvSpPr/>
              <p:nvPr/>
            </p:nvSpPr>
            <p:spPr>
              <a:xfrm flipV="1">
                <a:off x="5489640" y="7726320"/>
                <a:ext cx="750960" cy="1713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9" name=""/>
              <p:cNvSpPr/>
              <p:nvPr/>
            </p:nvSpPr>
            <p:spPr>
              <a:xfrm flipV="1">
                <a:off x="4735440" y="7897320"/>
                <a:ext cx="754200" cy="1717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0" name=""/>
              <p:cNvSpPr/>
              <p:nvPr/>
            </p:nvSpPr>
            <p:spPr>
              <a:xfrm>
                <a:off x="4735440" y="8277120"/>
                <a:ext cx="1505160" cy="1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1" name=""/>
              <p:cNvSpPr/>
              <p:nvPr/>
            </p:nvSpPr>
            <p:spPr>
              <a:xfrm flipV="1">
                <a:off x="4735440" y="7129440"/>
                <a:ext cx="1800" cy="11476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2" name=""/>
              <p:cNvSpPr/>
              <p:nvPr/>
            </p:nvSpPr>
            <p:spPr>
              <a:xfrm>
                <a:off x="5902560" y="7243920"/>
                <a:ext cx="1836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CC : 0.438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3" name=""/>
              <p:cNvSpPr/>
              <p:nvPr/>
            </p:nvSpPr>
            <p:spPr>
              <a:xfrm>
                <a:off x="5900760" y="7331040"/>
                <a:ext cx="17280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Arial"/>
                  </a:rPr>
                  <a:t>p : &lt;0.001</a:t>
                </a:r>
                <a:endParaRPr b="0" lang="en-US" sz="3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10-04T15:23:42Z</dcterms:created>
  <dc:creator>etudiants Pierrette</dc:creator>
  <dc:description/>
  <dc:language>en-US</dc:language>
  <cp:lastModifiedBy> barbara</cp:lastModifiedBy>
  <dcterms:modified xsi:type="dcterms:W3CDTF">2007-06-28T13:15:12Z</dcterms:modified>
  <cp:revision>4</cp:revision>
  <dc:subject/>
  <dc:title>Présentation PowerPoint</dc:title>
</cp:coreProperties>
</file>